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6" r:id="rId2"/>
    <p:sldId id="260" r:id="rId3"/>
    <p:sldId id="264" r:id="rId4"/>
    <p:sldId id="267" r:id="rId5"/>
    <p:sldId id="257" r:id="rId6"/>
    <p:sldId id="261" r:id="rId7"/>
    <p:sldId id="262" r:id="rId8"/>
    <p:sldId id="266" r:id="rId9"/>
    <p:sldId id="258" r:id="rId10"/>
    <p:sldId id="259" r:id="rId11"/>
    <p:sldId id="263" r:id="rId12"/>
    <p:sldId id="265" r:id="rId1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706" autoAdjust="0"/>
  </p:normalViewPr>
  <p:slideViewPr>
    <p:cSldViewPr snapToGrid="0">
      <p:cViewPr>
        <p:scale>
          <a:sx n="114" d="100"/>
          <a:sy n="114" d="100"/>
        </p:scale>
        <p:origin x="43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1E3B46-7068-4464-B7EA-2EF097CCFEF6}" type="datetimeFigureOut">
              <a:rPr lang="it-IT" smtClean="0"/>
              <a:t>14/12/2018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A81938-0EAC-479A-9322-BC12C07F1F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36171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81938-0EAC-479A-9322-BC12C07F1F70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439660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81938-0EAC-479A-9322-BC12C07F1F70}" type="slidenum">
              <a:rPr lang="it-IT" smtClean="0"/>
              <a:t>10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9098702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81938-0EAC-479A-9322-BC12C07F1F70}" type="slidenum">
              <a:rPr lang="it-IT" smtClean="0"/>
              <a:t>1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5416426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Fp84 </a:t>
            </a:r>
            <a:r>
              <a:rPr lang="it-IT" dirty="0" err="1"/>
              <a:t>Ck</a:t>
            </a:r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81938-0EAC-479A-9322-BC12C07F1F70}" type="slidenum">
              <a:rPr lang="it-IT" smtClean="0"/>
              <a:t>1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00226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81938-0EAC-479A-9322-BC12C07F1F70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485294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81938-0EAC-479A-9322-BC12C07F1F70}" type="slidenum">
              <a:rPr lang="it-IT" smtClean="0"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022568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81938-0EAC-479A-9322-BC12C07F1F70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9259452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81938-0EAC-479A-9322-BC12C07F1F70}" type="slidenum">
              <a:rPr lang="it-IT" smtClean="0"/>
              <a:t>5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472998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81938-0EAC-479A-9322-BC12C07F1F70}" type="slidenum">
              <a:rPr lang="it-IT" smtClean="0"/>
              <a:t>6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4710628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81938-0EAC-479A-9322-BC12C07F1F70}" type="slidenum">
              <a:rPr lang="it-IT" smtClean="0"/>
              <a:t>7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725608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81938-0EAC-479A-9322-BC12C07F1F70}" type="slidenum">
              <a:rPr lang="it-IT" smtClean="0"/>
              <a:t>8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724077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Fp84 Singoli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A81938-0EAC-479A-9322-BC12C07F1F70}" type="slidenum">
              <a:rPr lang="it-IT" smtClean="0"/>
              <a:t>9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47290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631F-AA73-4BAA-8DC4-B3833AD21BA9}" type="datetimeFigureOut">
              <a:rPr lang="it-IT" smtClean="0"/>
              <a:t>14/12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732F5-0409-4060-95A2-866390A98D9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05774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631F-AA73-4BAA-8DC4-B3833AD21BA9}" type="datetimeFigureOut">
              <a:rPr lang="it-IT" smtClean="0"/>
              <a:t>14/12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732F5-0409-4060-95A2-866390A98D9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2901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631F-AA73-4BAA-8DC4-B3833AD21BA9}" type="datetimeFigureOut">
              <a:rPr lang="it-IT" smtClean="0"/>
              <a:t>14/12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732F5-0409-4060-95A2-866390A98D9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06818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631F-AA73-4BAA-8DC4-B3833AD21BA9}" type="datetimeFigureOut">
              <a:rPr lang="it-IT" smtClean="0"/>
              <a:t>14/12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732F5-0409-4060-95A2-866390A98D9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87484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631F-AA73-4BAA-8DC4-B3833AD21BA9}" type="datetimeFigureOut">
              <a:rPr lang="it-IT" smtClean="0"/>
              <a:t>14/12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732F5-0409-4060-95A2-866390A98D9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1822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631F-AA73-4BAA-8DC4-B3833AD21BA9}" type="datetimeFigureOut">
              <a:rPr lang="it-IT" smtClean="0"/>
              <a:t>14/12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732F5-0409-4060-95A2-866390A98D9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2939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631F-AA73-4BAA-8DC4-B3833AD21BA9}" type="datetimeFigureOut">
              <a:rPr lang="it-IT" smtClean="0"/>
              <a:t>14/12/2018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732F5-0409-4060-95A2-866390A98D9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5416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631F-AA73-4BAA-8DC4-B3833AD21BA9}" type="datetimeFigureOut">
              <a:rPr lang="it-IT" smtClean="0"/>
              <a:t>14/12/2018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732F5-0409-4060-95A2-866390A98D9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2194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631F-AA73-4BAA-8DC4-B3833AD21BA9}" type="datetimeFigureOut">
              <a:rPr lang="it-IT" smtClean="0"/>
              <a:t>14/12/2018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732F5-0409-4060-95A2-866390A98D9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3805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631F-AA73-4BAA-8DC4-B3833AD21BA9}" type="datetimeFigureOut">
              <a:rPr lang="it-IT" smtClean="0"/>
              <a:t>14/12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732F5-0409-4060-95A2-866390A98D9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5003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631F-AA73-4BAA-8DC4-B3833AD21BA9}" type="datetimeFigureOut">
              <a:rPr lang="it-IT" smtClean="0"/>
              <a:t>14/12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732F5-0409-4060-95A2-866390A98D9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9673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7E631F-AA73-4BAA-8DC4-B3833AD21BA9}" type="datetimeFigureOut">
              <a:rPr lang="it-IT" smtClean="0"/>
              <a:t>14/12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F732F5-0409-4060-95A2-866390A98D9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1126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b="14969"/>
          <a:stretch/>
        </p:blipFill>
        <p:spPr>
          <a:xfrm>
            <a:off x="436397" y="525667"/>
            <a:ext cx="8322592" cy="521180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29430" y="114300"/>
            <a:ext cx="904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</a:p>
        </p:txBody>
      </p:sp>
    </p:spTree>
    <p:extLst>
      <p:ext uri="{BB962C8B-B14F-4D97-AF65-F5344CB8AC3E}">
        <p14:creationId xmlns:p14="http://schemas.microsoft.com/office/powerpoint/2010/main" val="171573589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b="15310"/>
          <a:stretch/>
        </p:blipFill>
        <p:spPr>
          <a:xfrm>
            <a:off x="211730" y="642302"/>
            <a:ext cx="8357680" cy="52128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927AC58-8F00-4763-A9A1-D7DECAD84CA6}"/>
              </a:ext>
            </a:extLst>
          </p:cNvPr>
          <p:cNvSpPr txBox="1"/>
          <p:nvPr/>
        </p:nvSpPr>
        <p:spPr>
          <a:xfrm>
            <a:off x="129430" y="114300"/>
            <a:ext cx="10534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. </a:t>
            </a:r>
          </a:p>
        </p:txBody>
      </p:sp>
    </p:spTree>
    <p:extLst>
      <p:ext uri="{BB962C8B-B14F-4D97-AF65-F5344CB8AC3E}">
        <p14:creationId xmlns:p14="http://schemas.microsoft.com/office/powerpoint/2010/main" val="188184609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b="15462"/>
          <a:stretch/>
        </p:blipFill>
        <p:spPr>
          <a:xfrm>
            <a:off x="252673" y="633020"/>
            <a:ext cx="8386846" cy="52128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7B3B5CA-DC01-49C0-ADE4-332903730378}"/>
              </a:ext>
            </a:extLst>
          </p:cNvPr>
          <p:cNvSpPr txBox="1"/>
          <p:nvPr/>
        </p:nvSpPr>
        <p:spPr>
          <a:xfrm>
            <a:off x="129430" y="114300"/>
            <a:ext cx="10534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1. </a:t>
            </a:r>
          </a:p>
        </p:txBody>
      </p:sp>
    </p:spTree>
    <p:extLst>
      <p:ext uri="{BB962C8B-B14F-4D97-AF65-F5344CB8AC3E}">
        <p14:creationId xmlns:p14="http://schemas.microsoft.com/office/powerpoint/2010/main" val="27016550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b="15320"/>
          <a:stretch/>
        </p:blipFill>
        <p:spPr>
          <a:xfrm>
            <a:off x="252673" y="535985"/>
            <a:ext cx="8372860" cy="52128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BE7F52A-19DD-46DC-A3B0-8AD80ADD3937}"/>
              </a:ext>
            </a:extLst>
          </p:cNvPr>
          <p:cNvSpPr txBox="1"/>
          <p:nvPr/>
        </p:nvSpPr>
        <p:spPr>
          <a:xfrm>
            <a:off x="129430" y="114300"/>
            <a:ext cx="10534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2. </a:t>
            </a:r>
          </a:p>
        </p:txBody>
      </p:sp>
    </p:spTree>
    <p:extLst>
      <p:ext uri="{BB962C8B-B14F-4D97-AF65-F5344CB8AC3E}">
        <p14:creationId xmlns:p14="http://schemas.microsoft.com/office/powerpoint/2010/main" val="33577055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b="15141"/>
          <a:stretch/>
        </p:blipFill>
        <p:spPr>
          <a:xfrm>
            <a:off x="465368" y="569266"/>
            <a:ext cx="8336020" cy="520967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7BBD6B6-65B9-4D44-880A-6F5CB4BA7552}"/>
              </a:ext>
            </a:extLst>
          </p:cNvPr>
          <p:cNvSpPr txBox="1"/>
          <p:nvPr/>
        </p:nvSpPr>
        <p:spPr>
          <a:xfrm>
            <a:off x="129430" y="114300"/>
            <a:ext cx="904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</a:p>
        </p:txBody>
      </p:sp>
    </p:spTree>
    <p:extLst>
      <p:ext uri="{BB962C8B-B14F-4D97-AF65-F5344CB8AC3E}">
        <p14:creationId xmlns:p14="http://schemas.microsoft.com/office/powerpoint/2010/main" val="39791690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b="15832"/>
          <a:stretch/>
        </p:blipFill>
        <p:spPr>
          <a:xfrm>
            <a:off x="252673" y="513951"/>
            <a:ext cx="8323200" cy="515052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839ED94-F2C6-4C64-8D2D-144CFA2C0F1C}"/>
              </a:ext>
            </a:extLst>
          </p:cNvPr>
          <p:cNvSpPr txBox="1"/>
          <p:nvPr/>
        </p:nvSpPr>
        <p:spPr>
          <a:xfrm>
            <a:off x="129430" y="114300"/>
            <a:ext cx="904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</a:p>
        </p:txBody>
      </p:sp>
    </p:spTree>
    <p:extLst>
      <p:ext uri="{BB962C8B-B14F-4D97-AF65-F5344CB8AC3E}">
        <p14:creationId xmlns:p14="http://schemas.microsoft.com/office/powerpoint/2010/main" val="10853961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b="15531"/>
          <a:stretch/>
        </p:blipFill>
        <p:spPr>
          <a:xfrm>
            <a:off x="364958" y="578106"/>
            <a:ext cx="8416048" cy="522664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C8E35C0-798A-4C32-AF3F-DF9BEEA3C2A2}"/>
              </a:ext>
            </a:extLst>
          </p:cNvPr>
          <p:cNvSpPr txBox="1"/>
          <p:nvPr/>
        </p:nvSpPr>
        <p:spPr>
          <a:xfrm>
            <a:off x="129430" y="114300"/>
            <a:ext cx="904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</a:p>
        </p:txBody>
      </p:sp>
    </p:spTree>
    <p:extLst>
      <p:ext uri="{BB962C8B-B14F-4D97-AF65-F5344CB8AC3E}">
        <p14:creationId xmlns:p14="http://schemas.microsoft.com/office/powerpoint/2010/main" val="10631825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b="15479"/>
          <a:stretch/>
        </p:blipFill>
        <p:spPr>
          <a:xfrm>
            <a:off x="317500" y="624854"/>
            <a:ext cx="8323200" cy="518092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DCEFD8B-F358-4BF0-9FB8-F7D46EF378ED}"/>
              </a:ext>
            </a:extLst>
          </p:cNvPr>
          <p:cNvSpPr txBox="1"/>
          <p:nvPr/>
        </p:nvSpPr>
        <p:spPr>
          <a:xfrm>
            <a:off x="129430" y="114300"/>
            <a:ext cx="904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</a:p>
        </p:txBody>
      </p:sp>
    </p:spTree>
    <p:extLst>
      <p:ext uri="{BB962C8B-B14F-4D97-AF65-F5344CB8AC3E}">
        <p14:creationId xmlns:p14="http://schemas.microsoft.com/office/powerpoint/2010/main" val="8548439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b="15649"/>
          <a:stretch/>
        </p:blipFill>
        <p:spPr>
          <a:xfrm>
            <a:off x="237888" y="532490"/>
            <a:ext cx="8373829" cy="5202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10DAA4F-4509-4D85-AB00-81443DFF4C16}"/>
              </a:ext>
            </a:extLst>
          </p:cNvPr>
          <p:cNvSpPr txBox="1"/>
          <p:nvPr/>
        </p:nvSpPr>
        <p:spPr>
          <a:xfrm>
            <a:off x="129430" y="114300"/>
            <a:ext cx="904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</a:p>
        </p:txBody>
      </p:sp>
    </p:spTree>
    <p:extLst>
      <p:ext uri="{BB962C8B-B14F-4D97-AF65-F5344CB8AC3E}">
        <p14:creationId xmlns:p14="http://schemas.microsoft.com/office/powerpoint/2010/main" val="38450232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b="15112"/>
          <a:stretch/>
        </p:blipFill>
        <p:spPr>
          <a:xfrm>
            <a:off x="252673" y="627010"/>
            <a:ext cx="8352351" cy="52128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0DB8F47-A952-4D2B-A576-85EB6EF7FA9E}"/>
              </a:ext>
            </a:extLst>
          </p:cNvPr>
          <p:cNvSpPr txBox="1"/>
          <p:nvPr/>
        </p:nvSpPr>
        <p:spPr>
          <a:xfrm>
            <a:off x="129430" y="114300"/>
            <a:ext cx="904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 </a:t>
            </a:r>
          </a:p>
        </p:txBody>
      </p:sp>
    </p:spTree>
    <p:extLst>
      <p:ext uri="{BB962C8B-B14F-4D97-AF65-F5344CB8AC3E}">
        <p14:creationId xmlns:p14="http://schemas.microsoft.com/office/powerpoint/2010/main" val="38671415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b="16258"/>
          <a:stretch/>
        </p:blipFill>
        <p:spPr>
          <a:xfrm>
            <a:off x="252673" y="593590"/>
            <a:ext cx="8466615" cy="52128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E445DE8-5251-4446-84FD-6E803B36F433}"/>
              </a:ext>
            </a:extLst>
          </p:cNvPr>
          <p:cNvSpPr txBox="1"/>
          <p:nvPr/>
        </p:nvSpPr>
        <p:spPr>
          <a:xfrm>
            <a:off x="129430" y="114300"/>
            <a:ext cx="904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. </a:t>
            </a:r>
          </a:p>
        </p:txBody>
      </p:sp>
    </p:spTree>
    <p:extLst>
      <p:ext uri="{BB962C8B-B14F-4D97-AF65-F5344CB8AC3E}">
        <p14:creationId xmlns:p14="http://schemas.microsoft.com/office/powerpoint/2010/main" val="18829386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b="14808"/>
          <a:stretch/>
        </p:blipFill>
        <p:spPr>
          <a:xfrm>
            <a:off x="317500" y="687287"/>
            <a:ext cx="8436913" cy="529338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CD47942-CC95-4778-920F-F58330B8DC5B}"/>
              </a:ext>
            </a:extLst>
          </p:cNvPr>
          <p:cNvSpPr txBox="1"/>
          <p:nvPr/>
        </p:nvSpPr>
        <p:spPr>
          <a:xfrm>
            <a:off x="129430" y="114300"/>
            <a:ext cx="904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. </a:t>
            </a:r>
          </a:p>
        </p:txBody>
      </p:sp>
    </p:spTree>
    <p:extLst>
      <p:ext uri="{BB962C8B-B14F-4D97-AF65-F5344CB8AC3E}">
        <p14:creationId xmlns:p14="http://schemas.microsoft.com/office/powerpoint/2010/main" val="2279391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Widescreen</PresentationFormat>
  <Paragraphs>26</Paragraphs>
  <Slides>12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a Roscini</dc:creator>
  <cp:lastModifiedBy>Laura Corte</cp:lastModifiedBy>
  <cp:revision>21</cp:revision>
  <dcterms:created xsi:type="dcterms:W3CDTF">2018-10-02T20:50:34Z</dcterms:created>
  <dcterms:modified xsi:type="dcterms:W3CDTF">2018-12-14T13:04:00Z</dcterms:modified>
</cp:coreProperties>
</file>